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  <p:sldId id="261" r:id="rId4"/>
    <p:sldId id="262" r:id="rId5"/>
    <p:sldId id="263" r:id="rId6"/>
    <p:sldId id="264" r:id="rId7"/>
    <p:sldId id="265" r:id="rId8"/>
    <p:sldId id="266" r:id="rId9"/>
    <p:sldId id="267" r:id="rId10"/>
    <p:sldId id="268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0" d="100"/>
          <a:sy n="100" d="100"/>
        </p:scale>
        <p:origin x="9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007644-709F-ED36-73F7-FDE940DE791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819E45C-129E-D942-76D6-0190F1CF6A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49404E6-2953-CBEC-7BAA-E5F94DFF2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59E3-9A78-4BCF-A5F2-207953388D35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539C00D-17D9-6077-9F16-72D059121E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C4E4C1D-829C-2F23-6E1D-5CEA5B0CD2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8340-B743-4778-9263-D4B1FB3CF9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4221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7410D9-7349-E695-BB5D-0E6D26F1EF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9AF4ACA-46C9-6F18-49C5-70F90F2AAE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BBC149-573D-9407-5C4D-7356AC12A5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59E3-9A78-4BCF-A5F2-207953388D35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9895C17-7B9B-0ACC-68F4-692FEBDF6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EB23E8B-770F-072E-3A25-CAAC94098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8340-B743-4778-9263-D4B1FB3CF9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2610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F373CE3-2ABC-9163-ECD2-1648C396A5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796009E-B917-203F-7744-270B8B7C0D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A73575-7CBF-2529-CD35-37685C05F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59E3-9A78-4BCF-A5F2-207953388D35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2DBC35E-0EB0-12F4-0D75-9CA472CA9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0C54F6B-C641-F4BA-172C-6EB4A3429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8340-B743-4778-9263-D4B1FB3CF9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040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BC55E2-D99A-4B9A-38E2-BBABC2472D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5870361-B6BF-C728-B134-F3F64D84E1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0C9EB33-58BE-BCCB-F755-5DEE57B1C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59E3-9A78-4BCF-A5F2-207953388D35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B39EC29-A96E-0772-B3E8-9B43109E9F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49FC2F-F432-9F5E-EBA5-47BFC8173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8340-B743-4778-9263-D4B1FB3CF9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148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C8AC7D-0092-5D49-508C-19CCA4D394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6866F75-7668-9F79-422E-D0946B0B99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B85BE8-7E43-47A7-E045-D85167D76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59E3-9A78-4BCF-A5F2-207953388D35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371B92-3BFF-EF53-D682-0459D73724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9E528F-F61E-D6B6-E2ED-E75BD8A90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8340-B743-4778-9263-D4B1FB3CF9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01848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FBC24D-0FB9-5776-4400-3593A6D627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221D322-6147-352D-1896-761FA7BE40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6F370DF-5F42-AB99-9A86-7C70CADE4E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817C378-E837-4316-0E84-78D0A8EFA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59E3-9A78-4BCF-A5F2-207953388D35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DB5B76A-AEC9-3616-24FF-B7804E5D7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20AD326-904F-9E1C-0D2E-62728F6F16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8340-B743-4778-9263-D4B1FB3CF9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8665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F95B93-B880-A26D-0ADE-2708F3E19C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9628441-7F12-FB18-ACE3-9320A69CD1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2B3B4B6-9E52-8BC3-4EB2-1CF912F219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9316B03-BB44-18EA-414B-49A78CDC88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AE79CFB-11A8-EE93-831D-8FFC1E6403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9899766-1208-9E29-E07B-FD4B6DA1B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59E3-9A78-4BCF-A5F2-207953388D35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9076779-DAB7-814B-ECD4-2D246DE4D3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660C589-EB1C-30CD-21C3-220882606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8340-B743-4778-9263-D4B1FB3CF9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5262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9984FA-D39C-37FA-F8D6-E8693A4582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759B4C8-14A3-5289-79DE-DEAF94A79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59E3-9A78-4BCF-A5F2-207953388D35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68444C2-E2E5-3097-AC13-4ABEBA1884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5ED1D05-A4E4-C9EB-0135-766CF122A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8340-B743-4778-9263-D4B1FB3CF9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7012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6EF8310-0E31-97F7-11AA-20B33718F6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59E3-9A78-4BCF-A5F2-207953388D35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25D6888-6EB6-7CF2-A5A1-BF5A3A29AC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94035FA-B3C8-E65C-C32B-3F96E3755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8340-B743-4778-9263-D4B1FB3CF9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2270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3FEBC1-B917-B885-A3B1-5F05BCC5A7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C55D2AB-81A1-60A6-79B3-6B3175E182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09616F4-1585-50C9-E0C9-E1B5F415BE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F6DC394-B199-56D1-A308-ECCA6A18CC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59E3-9A78-4BCF-A5F2-207953388D35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BFBFDDB-BFAB-5300-7319-805E3242E6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68F3A14-E583-C04E-1C7C-C85BFF9B6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8340-B743-4778-9263-D4B1FB3CF9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2645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B3F8D0-CBB9-2E6A-83C7-DB557CC24F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DA92116-69D9-779A-A151-7311CFA75B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3FEF24E-AEBE-4CD1-6200-836EC99B82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12445C8-06D4-B8B4-4968-DC083FD8CA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59E3-9A78-4BCF-A5F2-207953388D35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2A07FA7-925F-7B27-13F4-54CE47FC5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BF387AC-BD75-6EB3-E040-9FCFDF401A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D8340-B743-4778-9263-D4B1FB3CF9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1105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E52BE18-59D5-047F-D956-5703B30072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29B3BF1-AD0A-AC2F-F2C9-C618A09882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0CB32ED-CD1F-3916-449D-3E69246695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CA59E3-9A78-4BCF-A5F2-207953388D35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813BA1F-8155-C75F-6EF6-674765001E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F9AEB03-4AC3-DB27-50D5-908685CFCC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D8340-B743-4778-9263-D4B1FB3CF9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8051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244597CF-E29E-961E-8950-45053BA3B7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3697" y="148640"/>
            <a:ext cx="10724606" cy="596477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745EE069-AC51-A1E4-8713-0F9C7BDAB504}"/>
              </a:ext>
            </a:extLst>
          </p:cNvPr>
          <p:cNvSpPr txBox="1"/>
          <p:nvPr/>
        </p:nvSpPr>
        <p:spPr>
          <a:xfrm>
            <a:off x="600891" y="6322423"/>
            <a:ext cx="103784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Asthma of LHGS</a:t>
            </a:r>
            <a:endParaRPr lang="zh-CN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4490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1F825DA9-182F-32FC-7559-44353F999C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5502" y="260146"/>
            <a:ext cx="11220995" cy="5931648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91BB69B7-B28B-C07A-7DB0-9E6A4A3E9BDD}"/>
              </a:ext>
            </a:extLst>
          </p:cNvPr>
          <p:cNvSpPr txBox="1"/>
          <p:nvPr/>
        </p:nvSpPr>
        <p:spPr>
          <a:xfrm>
            <a:off x="202474" y="6466114"/>
            <a:ext cx="119394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0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Forest plot (A), leave-one-out analysis (B), scatter plot (C) and funnel plot (D) of the effect </a:t>
            </a:r>
            <a:r>
              <a:rPr lang="en-US" altLang="zh-CN" sz="16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ron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f HGS(R</a:t>
            </a:r>
            <a:r>
              <a:rPr lang="zh-CN" alt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）</a:t>
            </a:r>
            <a:endParaRPr lang="en-US" altLang="zh-CN" sz="1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03256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AA47768-47A7-465E-EF71-163D46CCB6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2331" y="187829"/>
            <a:ext cx="10874829" cy="5905994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02C31886-C684-2C53-C44C-9BD6F6FE3469}"/>
              </a:ext>
            </a:extLst>
          </p:cNvPr>
          <p:cNvSpPr txBox="1"/>
          <p:nvPr/>
        </p:nvSpPr>
        <p:spPr>
          <a:xfrm>
            <a:off x="502920" y="6355080"/>
            <a:ext cx="105874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2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Asthma of USP</a:t>
            </a:r>
          </a:p>
        </p:txBody>
      </p:sp>
    </p:spTree>
    <p:extLst>
      <p:ext uri="{BB962C8B-B14F-4D97-AF65-F5344CB8AC3E}">
        <p14:creationId xmlns:p14="http://schemas.microsoft.com/office/powerpoint/2010/main" val="33603454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A45B9E7-A7E9-C69A-669A-962AF87C0C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1297" y="281918"/>
            <a:ext cx="11103429" cy="589028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F8B88426-4255-FCAE-F01E-65F98E972679}"/>
              </a:ext>
            </a:extLst>
          </p:cNvPr>
          <p:cNvSpPr txBox="1"/>
          <p:nvPr/>
        </p:nvSpPr>
        <p:spPr>
          <a:xfrm>
            <a:off x="339634" y="6420394"/>
            <a:ext cx="114626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3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COPD of GHS(L)</a:t>
            </a:r>
          </a:p>
        </p:txBody>
      </p:sp>
    </p:spTree>
    <p:extLst>
      <p:ext uri="{BB962C8B-B14F-4D97-AF65-F5344CB8AC3E}">
        <p14:creationId xmlns:p14="http://schemas.microsoft.com/office/powerpoint/2010/main" val="16932327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7CBB6F26-3747-0712-0354-F9209B34C1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1886" y="297154"/>
            <a:ext cx="11390811" cy="599261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F1E09082-15A9-F5DD-9ABE-A605C584E55A}"/>
              </a:ext>
            </a:extLst>
          </p:cNvPr>
          <p:cNvSpPr txBox="1"/>
          <p:nvPr/>
        </p:nvSpPr>
        <p:spPr>
          <a:xfrm>
            <a:off x="306977" y="6466114"/>
            <a:ext cx="117696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4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</a:t>
            </a:r>
            <a:r>
              <a:rPr lang="en-US" altLang="zh-CN" sz="16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arc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f HGS(L)</a:t>
            </a:r>
          </a:p>
        </p:txBody>
      </p:sp>
    </p:spTree>
    <p:extLst>
      <p:ext uri="{BB962C8B-B14F-4D97-AF65-F5344CB8AC3E}">
        <p14:creationId xmlns:p14="http://schemas.microsoft.com/office/powerpoint/2010/main" val="19827082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297B622-78E5-D956-A033-6F2FF6BC5F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9858" y="285837"/>
            <a:ext cx="11227525" cy="5971272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8A7954D5-AD2B-AD1C-81E0-E821C14F9D67}"/>
              </a:ext>
            </a:extLst>
          </p:cNvPr>
          <p:cNvSpPr txBox="1"/>
          <p:nvPr/>
        </p:nvSpPr>
        <p:spPr>
          <a:xfrm>
            <a:off x="339635" y="6335486"/>
            <a:ext cx="117696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5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</a:t>
            </a:r>
            <a:r>
              <a:rPr lang="en-US" altLang="zh-CN" sz="16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arc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f LHGS</a:t>
            </a:r>
          </a:p>
        </p:txBody>
      </p:sp>
    </p:spTree>
    <p:extLst>
      <p:ext uri="{BB962C8B-B14F-4D97-AF65-F5344CB8AC3E}">
        <p14:creationId xmlns:p14="http://schemas.microsoft.com/office/powerpoint/2010/main" val="18507583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EC18CA65-E8B7-E24C-B35D-9E4DF77A74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1297" y="263190"/>
            <a:ext cx="11155680" cy="5830633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4CF36C5A-EBA0-B0C2-E7C1-B0BDFEE4B5EB}"/>
              </a:ext>
            </a:extLst>
          </p:cNvPr>
          <p:cNvSpPr txBox="1"/>
          <p:nvPr/>
        </p:nvSpPr>
        <p:spPr>
          <a:xfrm>
            <a:off x="411480" y="6407331"/>
            <a:ext cx="114757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6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</a:t>
            </a:r>
            <a:r>
              <a:rPr lang="en-US" altLang="zh-CN" sz="16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arc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f USP</a:t>
            </a:r>
          </a:p>
        </p:txBody>
      </p:sp>
    </p:spTree>
    <p:extLst>
      <p:ext uri="{BB962C8B-B14F-4D97-AF65-F5344CB8AC3E}">
        <p14:creationId xmlns:p14="http://schemas.microsoft.com/office/powerpoint/2010/main" val="17853901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75A6964-A3A6-FB67-EA66-C101CFB1A0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5503" y="251438"/>
            <a:ext cx="11220994" cy="5992607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FABE2197-97A6-F453-A8A1-D5E7C4E24A03}"/>
              </a:ext>
            </a:extLst>
          </p:cNvPr>
          <p:cNvSpPr txBox="1"/>
          <p:nvPr/>
        </p:nvSpPr>
        <p:spPr>
          <a:xfrm>
            <a:off x="254726" y="6407331"/>
            <a:ext cx="11658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7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</a:t>
            </a:r>
            <a:r>
              <a:rPr lang="en-US" altLang="zh-CN" sz="16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neu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f ALM</a:t>
            </a:r>
          </a:p>
        </p:txBody>
      </p:sp>
    </p:spTree>
    <p:extLst>
      <p:ext uri="{BB962C8B-B14F-4D97-AF65-F5344CB8AC3E}">
        <p14:creationId xmlns:p14="http://schemas.microsoft.com/office/powerpoint/2010/main" val="26553588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02B7422-338A-3F72-AAA3-20CAFABA52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2120" y="218347"/>
            <a:ext cx="11150759" cy="5966916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5A7BA1AC-A3AA-61D8-0E2F-9DB7F269481B}"/>
              </a:ext>
            </a:extLst>
          </p:cNvPr>
          <p:cNvSpPr txBox="1"/>
          <p:nvPr/>
        </p:nvSpPr>
        <p:spPr>
          <a:xfrm>
            <a:off x="306977" y="6407331"/>
            <a:ext cx="117108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8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IRTI of HGS(R)</a:t>
            </a:r>
          </a:p>
        </p:txBody>
      </p:sp>
    </p:spTree>
    <p:extLst>
      <p:ext uri="{BB962C8B-B14F-4D97-AF65-F5344CB8AC3E}">
        <p14:creationId xmlns:p14="http://schemas.microsoft.com/office/powerpoint/2010/main" val="15651116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70DF66DD-46AE-F91A-D77C-7C7993B3CC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829" y="254922"/>
            <a:ext cx="11064240" cy="5904215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281891DE-2615-9E80-CEF3-1F6DA6B8E5A4}"/>
              </a:ext>
            </a:extLst>
          </p:cNvPr>
          <p:cNvSpPr txBox="1"/>
          <p:nvPr/>
        </p:nvSpPr>
        <p:spPr>
          <a:xfrm>
            <a:off x="313509" y="6368143"/>
            <a:ext cx="115606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9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IRIT of LHGS</a:t>
            </a:r>
          </a:p>
        </p:txBody>
      </p:sp>
    </p:spTree>
    <p:extLst>
      <p:ext uri="{BB962C8B-B14F-4D97-AF65-F5344CB8AC3E}">
        <p14:creationId xmlns:p14="http://schemas.microsoft.com/office/powerpoint/2010/main" val="4535754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</TotalTime>
  <Words>312</Words>
  <Application>Microsoft Office PowerPoint</Application>
  <PresentationFormat>宽屏</PresentationFormat>
  <Paragraphs>10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5" baseType="lpstr">
      <vt:lpstr>等线</vt:lpstr>
      <vt:lpstr>等线 Light</vt:lpstr>
      <vt:lpstr>Arial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yuhan</dc:creator>
  <cp:lastModifiedBy>张 有千</cp:lastModifiedBy>
  <cp:revision>4</cp:revision>
  <dcterms:created xsi:type="dcterms:W3CDTF">2023-07-05T07:07:28Z</dcterms:created>
  <dcterms:modified xsi:type="dcterms:W3CDTF">2023-07-11T16:29:12Z</dcterms:modified>
</cp:coreProperties>
</file>